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2308655" y="457200"/>
            <a:ext cx="3943131" cy="4715824"/>
            <a:chOff x="2819400" y="914400"/>
            <a:chExt cx="3432387" cy="4333567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DCE59603-F7B1-4C9E-B645-6A321048626F}"/>
                </a:ext>
              </a:extLst>
            </p:cNvPr>
            <p:cNvGrpSpPr/>
            <p:nvPr/>
          </p:nvGrpSpPr>
          <p:grpSpPr>
            <a:xfrm>
              <a:off x="2819400" y="914400"/>
              <a:ext cx="3432387" cy="4333567"/>
              <a:chOff x="0" y="516241"/>
              <a:chExt cx="4729067" cy="5715754"/>
            </a:xfrm>
          </p:grpSpPr>
          <p:pic>
            <p:nvPicPr>
              <p:cNvPr id="3" name="Picture 2" descr="A close up of a map&#10;&#10;Description generated with high confidence">
                <a:extLst>
                  <a:ext uri="{FF2B5EF4-FFF2-40B4-BE49-F238E27FC236}">
                    <a16:creationId xmlns:a16="http://schemas.microsoft.com/office/drawing/2014/main" xmlns="" id="{94FE9E8F-B379-4051-8321-6488AF4357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4243" r="31060" b="7457"/>
              <a:stretch/>
            </p:blipFill>
            <p:spPr>
              <a:xfrm>
                <a:off x="0" y="762000"/>
                <a:ext cx="4495800" cy="5469995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00E12F5E-E601-41CF-9B98-A9617FB8CC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24042" y="585560"/>
                <a:ext cx="277325" cy="176682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E12FFC67-ED09-4000-BE3D-D8621FD17C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624042" y="871521"/>
                <a:ext cx="277325" cy="176682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xmlns="" id="{9BDD197A-DE19-44EC-A160-78F1BAD4C27B}"/>
                  </a:ext>
                </a:extLst>
              </p:cNvPr>
              <p:cNvSpPr txBox="1"/>
              <p:nvPr/>
            </p:nvSpPr>
            <p:spPr>
              <a:xfrm>
                <a:off x="3882217" y="516241"/>
                <a:ext cx="784227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EN1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xmlns="" id="{B90858DD-462B-486F-8622-39352892812F}"/>
                  </a:ext>
                </a:extLst>
              </p:cNvPr>
              <p:cNvSpPr txBox="1"/>
              <p:nvPr/>
            </p:nvSpPr>
            <p:spPr>
              <a:xfrm>
                <a:off x="3882214" y="804383"/>
                <a:ext cx="846853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STN1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xmlns="" id="{C1489886-9709-4BE0-8BC2-840425F705DD}"/>
                  </a:ext>
                </a:extLst>
              </p:cNvPr>
              <p:cNvSpPr txBox="1"/>
              <p:nvPr/>
            </p:nvSpPr>
            <p:spPr>
              <a:xfrm>
                <a:off x="1952934" y="3646792"/>
                <a:ext cx="827179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sp78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xmlns="" id="{CC36BFFF-5781-44E3-9BC5-48DFD7BD012B}"/>
                  </a:ext>
                </a:extLst>
              </p:cNvPr>
              <p:cNvSpPr txBox="1"/>
              <p:nvPr/>
            </p:nvSpPr>
            <p:spPr>
              <a:xfrm>
                <a:off x="1752600" y="5258716"/>
                <a:ext cx="817577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hr62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xmlns="" id="{419A6F5D-03C0-4E0F-9CA0-9ED64A8D8A87}"/>
                  </a:ext>
                </a:extLst>
              </p:cNvPr>
              <p:cNvSpPr/>
              <p:nvPr/>
            </p:nvSpPr>
            <p:spPr>
              <a:xfrm>
                <a:off x="3624042" y="1162960"/>
                <a:ext cx="277325" cy="176682"/>
              </a:xfrm>
              <a:prstGeom prst="rect">
                <a:avLst/>
              </a:prstGeom>
              <a:solidFill>
                <a:srgbClr val="E329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000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xmlns="" id="{EFF06D2D-6FD9-49E6-AA02-6289598FC1EA}"/>
                  </a:ext>
                </a:extLst>
              </p:cNvPr>
              <p:cNvSpPr/>
              <p:nvPr/>
            </p:nvSpPr>
            <p:spPr>
              <a:xfrm>
                <a:off x="1752600" y="3681904"/>
                <a:ext cx="2667000" cy="2414096"/>
              </a:xfrm>
              <a:prstGeom prst="rect">
                <a:avLst/>
              </a:prstGeom>
              <a:noFill/>
              <a:ln w="19050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10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xmlns="" id="{98EDA5C8-677F-4000-8B55-F6112099C44E}"/>
                  </a:ext>
                </a:extLst>
              </p:cNvPr>
              <p:cNvSpPr txBox="1"/>
              <p:nvPr/>
            </p:nvSpPr>
            <p:spPr>
              <a:xfrm>
                <a:off x="3452593" y="4479964"/>
                <a:ext cx="1138440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rg27Glu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xmlns="" id="{960888FF-9F9E-44A5-8F3C-77FD7AD24100}"/>
                  </a:ext>
                </a:extLst>
              </p:cNvPr>
              <p:cNvSpPr txBox="1"/>
              <p:nvPr/>
            </p:nvSpPr>
            <p:spPr>
              <a:xfrm>
                <a:off x="2931250" y="5631613"/>
                <a:ext cx="950967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rp160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xmlns="" id="{A40C51FD-A805-43F7-9C34-DBC88CE2ED18}"/>
                  </a:ext>
                </a:extLst>
              </p:cNvPr>
              <p:cNvSpPr txBox="1"/>
              <p:nvPr/>
            </p:nvSpPr>
            <p:spPr>
              <a:xfrm>
                <a:off x="3546328" y="3352801"/>
                <a:ext cx="873271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Gly7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1472E591-DBB3-4A61-9272-F48148738703}"/>
                  </a:ext>
                </a:extLst>
              </p:cNvPr>
              <p:cNvSpPr txBox="1"/>
              <p:nvPr/>
            </p:nvSpPr>
            <p:spPr>
              <a:xfrm>
                <a:off x="1994225" y="3352801"/>
                <a:ext cx="846853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Ser80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xmlns="" id="{5025DB18-2F80-4063-ACFB-50ADCE65F6D7}"/>
                  </a:ext>
                </a:extLst>
              </p:cNvPr>
              <p:cNvSpPr txBox="1"/>
              <p:nvPr/>
            </p:nvSpPr>
            <p:spPr>
              <a:xfrm>
                <a:off x="2963147" y="2711710"/>
                <a:ext cx="1026347" cy="32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Gln112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17B79051-DE5C-428B-A7A4-F018ED588A8F}"/>
                  </a:ext>
                </a:extLst>
              </p:cNvPr>
              <p:cNvSpPr txBox="1"/>
              <p:nvPr/>
            </p:nvSpPr>
            <p:spPr>
              <a:xfrm>
                <a:off x="2699476" y="1932679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115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D425DAAB-0B5A-4BEB-A4D7-84717BC9C4B7}"/>
                  </a:ext>
                </a:extLst>
              </p:cNvPr>
              <p:cNvSpPr txBox="1"/>
              <p:nvPr/>
            </p:nvSpPr>
            <p:spPr>
              <a:xfrm>
                <a:off x="2925046" y="927176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Glu118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691C6CA7-DB36-456E-A608-E62DE0344733}"/>
                  </a:ext>
                </a:extLst>
              </p:cNvPr>
              <p:cNvSpPr txBox="1"/>
              <p:nvPr/>
            </p:nvSpPr>
            <p:spPr>
              <a:xfrm>
                <a:off x="2200313" y="594741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rg11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02335F31-EBD7-426A-A4B0-783F9E4632F7}"/>
                  </a:ext>
                </a:extLst>
              </p:cNvPr>
              <p:cNvSpPr txBox="1"/>
              <p:nvPr/>
            </p:nvSpPr>
            <p:spPr>
              <a:xfrm>
                <a:off x="653171" y="1893476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rg115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8A1AE62C-C0FC-425B-A029-21B53F3CE0E7}"/>
                  </a:ext>
                </a:extLst>
              </p:cNvPr>
              <p:cNvSpPr txBox="1"/>
              <p:nvPr/>
            </p:nvSpPr>
            <p:spPr>
              <a:xfrm>
                <a:off x="275011" y="1516317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sp33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xmlns="" id="{BDDC5BE9-3672-45E4-AF66-6A734CA259D8}"/>
                  </a:ext>
                </a:extLst>
              </p:cNvPr>
              <p:cNvSpPr txBox="1"/>
              <p:nvPr/>
            </p:nvSpPr>
            <p:spPr>
              <a:xfrm>
                <a:off x="698440" y="789788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Asp17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A4432736-1C59-4D07-BAA5-ADC7CF281B1F}"/>
                  </a:ext>
                </a:extLst>
              </p:cNvPr>
              <p:cNvSpPr txBox="1"/>
              <p:nvPr/>
            </p:nvSpPr>
            <p:spPr>
              <a:xfrm>
                <a:off x="275013" y="1139158"/>
                <a:ext cx="846853" cy="3247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Tyr49</a:t>
                </a:r>
                <a:endParaRPr lang="en-IN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4A59A2B0-65C8-44F5-9904-163AAB4F9920}"/>
                </a:ext>
              </a:extLst>
            </p:cNvPr>
            <p:cNvSpPr txBox="1"/>
            <p:nvPr/>
          </p:nvSpPr>
          <p:spPr>
            <a:xfrm>
              <a:off x="5614030" y="1351326"/>
              <a:ext cx="537572" cy="249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Glu27</a:t>
              </a:r>
              <a:endParaRPr lang="en-IN" sz="10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" name="Rectangle 26"/>
          <p:cNvSpPr/>
          <p:nvPr/>
        </p:nvSpPr>
        <p:spPr>
          <a:xfrm>
            <a:off x="457200" y="5595372"/>
            <a:ext cx="8382000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1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dirty="0" smtClean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Superimposed </a:t>
            </a:r>
            <a:r>
              <a:rPr lang="en-US" dirty="0" smtClean="0">
                <a:latin typeface="Times New Roman" pitchFamily="18" charset="0"/>
                <a:ea typeface="Tahoma" panose="020B0604030504040204" pitchFamily="34" charset="0"/>
                <a:cs typeface="Times New Roman" pitchFamily="18" charset="0"/>
              </a:rPr>
              <a:t>mutant R27Q (in magenta element color) TEN1 over wild-type where polar interactions between TEN1-STN1 complex were found to be effectively reduced.</a:t>
            </a:r>
            <a:endParaRPr lang="en-IN" dirty="0" smtClean="0">
              <a:latin typeface="Times New Roman" pitchFamily="18" charset="0"/>
              <a:ea typeface="Tahoma" panose="020B0604030504040204" pitchFamily="34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ayan</dc:creator>
  <cp:lastModifiedBy>rolex</cp:lastModifiedBy>
  <cp:revision>1</cp:revision>
  <dcterms:created xsi:type="dcterms:W3CDTF">2006-08-16T00:00:00Z</dcterms:created>
  <dcterms:modified xsi:type="dcterms:W3CDTF">2019-04-01T04:59:16Z</dcterms:modified>
</cp:coreProperties>
</file>